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photoAlbum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0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590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497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19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471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744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92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128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244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875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446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491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A3F60-208A-4855-8CF0-2D259B733151}" type="datetimeFigureOut">
              <a:rPr lang="en-US" smtClean="0"/>
              <a:t>4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ED9B8-A1E4-4BF5-8936-74512A2BD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575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/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5800" y="5867400"/>
            <a:ext cx="8077200" cy="804862"/>
          </a:xfrm>
        </p:spPr>
        <p:txBody>
          <a:bodyPr>
            <a:norm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s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mato leaf curl Sudan viru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oLCSDV)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cotiana benthamian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.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oLCSDV-inoculated plant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lose-up of a leaf lower surface of ToLCSDV-inoculated plant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ck-inoculated plant,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(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lose-up of a leaf lower surface of mock-inoculated plant. 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0" y="0"/>
            <a:ext cx="6686550" cy="5781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66800" y="32004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074816" y="17526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421662" y="320040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421662" y="175260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1346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</TotalTime>
  <Words>58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oto Album</dc:title>
  <dc:creator>Ali M Idris</dc:creator>
  <cp:lastModifiedBy>Ali M Idris</cp:lastModifiedBy>
  <cp:revision>15</cp:revision>
  <dcterms:created xsi:type="dcterms:W3CDTF">2014-03-12T10:08:33Z</dcterms:created>
  <dcterms:modified xsi:type="dcterms:W3CDTF">2014-04-18T13:36:58Z</dcterms:modified>
</cp:coreProperties>
</file>